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3976C9-2470-69D7-4B11-39F3EB6EC4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AB17A38-0204-3104-6E60-90FF47D175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FB8ACF-52F7-0C3A-57A8-DAB8A1A83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97134F-8B95-2A01-A81D-6A8452800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39514F-9AF7-D13D-16D1-B18C91591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297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474E00-994F-691E-D8DA-F41CAEFCEB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A8C42C9-72DE-B6B8-879D-045A629668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68E025-65A3-9072-E1EB-96E93DEC9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8FE2048-11EE-25B3-7ED8-C5A726815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5F075B-8FBE-7FC1-6C1B-711904581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315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A2FB9B2-AD85-3CED-EA30-6B7FE88054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9FE444-822C-CFB4-AFEE-56AD12E8FE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AC4FFC-DBBA-8CF6-7402-7BFD7C3DB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D8945F-2ABE-008F-E56C-B46A5E359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AAC38D-E296-A2FC-1F05-12DCFD7FD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778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BF86DA-646F-C0DD-D3DE-7EA441DD4D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625EF94-8008-5FA7-6AB1-53BDD9D305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CD7D47-8FA8-3D67-7846-B0602AAE7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C0D72D2-EE8C-8353-5322-4E4E48B40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F7A48E-9BA0-B24D-70B6-200A1BA34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976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17A4B7-B5D2-5B38-435E-C92A8227D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4003CFA-C17F-0F4F-3AA7-FF67BBBD0F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F39BDE5-6442-B387-8838-A35E521E3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02DB4B4-6505-BF53-13C0-861EC7CDE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3CA6B63-258F-3996-D520-FBADDCE87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3464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FCF1B6-542B-E509-6AF7-94CD5BA744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1B6D109-DDE2-D288-033A-879558BDF8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BB1A2CE-5575-B2ED-8B4E-4BF6304126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F4B3913-05D5-E7B9-78A7-C746DEFCB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A1E0F72-03C7-CDF8-05DD-444CB649D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5632D5C-B5C8-846A-A597-B81760284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339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DAAFD1-0AD8-5C62-2714-6CA64CE66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4AF01F-45C8-5E08-4C2D-597DD269FF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0BD9F7F-08F2-A13C-A7A1-8C7B7B6FEF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17896B5-8FD5-17AD-EB05-0F58B95ED7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0063311-A2AC-4DF4-6A1A-251E875000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B803912-66B7-4921-5B2D-02C610D1E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E01189D-82E5-F442-76E7-5ABE1227F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7765282-F625-C010-43EC-D503D4584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6423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23DD38-C636-97B1-6D5F-883799E588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A1A90CA-2140-F0EE-87BC-0BDC9B07D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1E10D52-6B55-57FF-74A6-539460B38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0128D5A-ABA6-81F4-B72C-BF51FC357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9870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1BAE8D9-34FE-DB34-1490-6B1EAA7F5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359C560-2EE6-6EA8-7C3C-46211DD7F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7A77F54-F474-15C3-4A71-BA0A9D5CB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77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C40B1B-D528-C3D6-BC42-F84CADD5AD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C68AEC-90A9-0044-6ED3-763278F640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4AF08C0-1905-8EE1-5302-1B15C9FFEF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3EE9140-3F0B-23FC-3066-C055A19C7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3269739-907E-821F-2209-740D7A4BD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C5B50A-691A-3E23-738F-4A23DCE29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889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76E2F4-B0F7-2D68-FCC4-11DD47D15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41E24A4-329E-D6FE-E1FB-19B9D48BB7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AC01461-8325-6387-77B0-1BE62B7E34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CCF5C8A-3F05-4305-CA4D-BE42317D1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9113ED8-C475-04DB-1751-5DC1CE3F5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56B55AD-49CF-AF24-EF7C-0A1EA1F1F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4553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9FE49C3-69F8-40DE-E441-7A4A7C410C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534997-9E37-41C2-A3F5-51C411823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FE8C42-64C9-32C8-2AA5-74EE2E2F2F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B35A0-D416-4DB9-9FD2-D03D1452A517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0C56EB8-3123-468F-B9DA-578AD34081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AC79E7-F91E-0E79-1E53-306CBD572C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257B84-3EAD-4BB7-92E5-1FC314E712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3533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B5F9660D-A3A1-058A-A473-2B9075BDEF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2158322"/>
              </p:ext>
            </p:extLst>
          </p:nvPr>
        </p:nvGraphicFramePr>
        <p:xfrm>
          <a:off x="1577171" y="1690254"/>
          <a:ext cx="7925315" cy="263754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324759">
                  <a:extLst>
                    <a:ext uri="{9D8B030D-6E8A-4147-A177-3AD203B41FA5}">
                      <a16:colId xmlns:a16="http://schemas.microsoft.com/office/drawing/2014/main" val="2255677552"/>
                    </a:ext>
                  </a:extLst>
                </a:gridCol>
                <a:gridCol w="1120111">
                  <a:extLst>
                    <a:ext uri="{9D8B030D-6E8A-4147-A177-3AD203B41FA5}">
                      <a16:colId xmlns:a16="http://schemas.microsoft.com/office/drawing/2014/main" val="3641621652"/>
                    </a:ext>
                  </a:extLst>
                </a:gridCol>
                <a:gridCol w="2810845">
                  <a:extLst>
                    <a:ext uri="{9D8B030D-6E8A-4147-A177-3AD203B41FA5}">
                      <a16:colId xmlns:a16="http://schemas.microsoft.com/office/drawing/2014/main" val="3992229721"/>
                    </a:ext>
                  </a:extLst>
                </a:gridCol>
                <a:gridCol w="1669600">
                  <a:extLst>
                    <a:ext uri="{9D8B030D-6E8A-4147-A177-3AD203B41FA5}">
                      <a16:colId xmlns:a16="http://schemas.microsoft.com/office/drawing/2014/main" val="743012033"/>
                    </a:ext>
                  </a:extLst>
                </a:gridCol>
              </a:tblGrid>
              <a:tr h="380415">
                <a:tc>
                  <a:txBody>
                    <a:bodyPr/>
                    <a:lstStyle/>
                    <a:p>
                      <a:pPr algn="l"/>
                      <a:r>
                        <a:rPr lang="en-US" sz="18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verse events</a:t>
                      </a:r>
                      <a:endParaRPr lang="ja-JP" sz="17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endParaRPr lang="ja-JP" sz="17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AE version 4.0</a:t>
                      </a:r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extLst>
                  <a:ext uri="{0D108BD9-81ED-4DB2-BD59-A6C34878D82A}">
                    <a16:rowId xmlns:a16="http://schemas.microsoft.com/office/drawing/2014/main" val="999081323"/>
                  </a:ext>
                </a:extLst>
              </a:tr>
              <a:tr h="380415">
                <a:tc>
                  <a:txBody>
                    <a:bodyPr/>
                    <a:lstStyle/>
                    <a:p>
                      <a:pPr algn="l"/>
                      <a:r>
                        <a:rPr lang="en-US" sz="18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xicity</a:t>
                      </a:r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700" b="1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 (%)</a:t>
                      </a:r>
                      <a:endParaRPr lang="ja-JP" altLang="ja-JP" sz="17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b="1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e 1-2</a:t>
                      </a:r>
                      <a:endParaRPr lang="ja-JP" sz="1700" b="1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b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e 3-4</a:t>
                      </a:r>
                      <a:endParaRPr lang="ja-JP" sz="17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extLst>
                  <a:ext uri="{0D108BD9-81ED-4DB2-BD59-A6C34878D82A}">
                    <a16:rowId xmlns:a16="http://schemas.microsoft.com/office/drawing/2014/main" val="2282999896"/>
                  </a:ext>
                </a:extLst>
              </a:tr>
              <a:tr h="380415">
                <a:tc>
                  <a:txBody>
                    <a:bodyPr/>
                    <a:lstStyle/>
                    <a:p>
                      <a:pPr algn="l"/>
                      <a:r>
                        <a:rPr lang="en-US" sz="18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emia</a:t>
                      </a:r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.0%)</a:t>
                      </a:r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8.3%)</a:t>
                      </a:r>
                      <a:endParaRPr lang="ja-JP" sz="17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extLst>
                  <a:ext uri="{0D108BD9-81ED-4DB2-BD59-A6C34878D82A}">
                    <a16:rowId xmlns:a16="http://schemas.microsoft.com/office/drawing/2014/main" val="2120635625"/>
                  </a:ext>
                </a:extLst>
              </a:tr>
              <a:tr h="557942">
                <a:tc>
                  <a:txBody>
                    <a:bodyPr/>
                    <a:lstStyle/>
                    <a:p>
                      <a:pPr algn="l"/>
                      <a:r>
                        <a:rPr lang="en-US" sz="18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brile neutropenia</a:t>
                      </a:r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.0%)</a:t>
                      </a:r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2.5%)</a:t>
                      </a:r>
                      <a:endParaRPr lang="ja-JP" sz="17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extLst>
                  <a:ext uri="{0D108BD9-81ED-4DB2-BD59-A6C34878D82A}">
                    <a16:rowId xmlns:a16="http://schemas.microsoft.com/office/drawing/2014/main" val="2175108741"/>
                  </a:ext>
                </a:extLst>
              </a:tr>
              <a:tr h="557942">
                <a:tc>
                  <a:txBody>
                    <a:bodyPr/>
                    <a:lstStyle/>
                    <a:p>
                      <a:pPr algn="l"/>
                      <a:r>
                        <a:rPr lang="en-US" sz="18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rombocytopenia</a:t>
                      </a:r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.0%)</a:t>
                      </a:r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.1%)</a:t>
                      </a:r>
                      <a:endParaRPr lang="ja-JP" sz="17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extLst>
                  <a:ext uri="{0D108BD9-81ED-4DB2-BD59-A6C34878D82A}">
                    <a16:rowId xmlns:a16="http://schemas.microsoft.com/office/drawing/2014/main" val="3597290727"/>
                  </a:ext>
                </a:extLst>
              </a:tr>
              <a:tr h="380415">
                <a:tc>
                  <a:txBody>
                    <a:bodyPr/>
                    <a:lstStyle/>
                    <a:p>
                      <a:pPr algn="l"/>
                      <a:r>
                        <a:rPr lang="en-US" sz="18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usea</a:t>
                      </a:r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endParaRPr lang="ja-JP" sz="17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.1%)</a:t>
                      </a:r>
                      <a:endParaRPr lang="ja-JP" sz="17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8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.0%)</a:t>
                      </a:r>
                      <a:endParaRPr lang="ja-JP" sz="17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04614" marR="104614" marT="0" marB="0" anchor="ctr"/>
                </a:tc>
                <a:extLst>
                  <a:ext uri="{0D108BD9-81ED-4DB2-BD59-A6C34878D82A}">
                    <a16:rowId xmlns:a16="http://schemas.microsoft.com/office/drawing/2014/main" val="1015436740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B7C787F-EC02-D659-2B99-3AA22FAED70E}"/>
              </a:ext>
            </a:extLst>
          </p:cNvPr>
          <p:cNvSpPr txBox="1"/>
          <p:nvPr/>
        </p:nvSpPr>
        <p:spPr>
          <a:xfrm>
            <a:off x="294019" y="260715"/>
            <a:ext cx="91009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. Adverse events due to </a:t>
            </a:r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cabazitaxel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treatmen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8703121-0CAB-6A31-5E86-17F16520A85E}"/>
              </a:ext>
            </a:extLst>
          </p:cNvPr>
          <p:cNvSpPr txBox="1"/>
          <p:nvPr/>
        </p:nvSpPr>
        <p:spPr>
          <a:xfrm>
            <a:off x="1128936" y="5167746"/>
            <a:ext cx="953417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he adverse events associated with the administration of </a:t>
            </a:r>
            <a:r>
              <a:rPr lang="en-US" altLang="ja-JP" sz="1800" kern="1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abazitaxel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were listed. To prevent neutropenia, all patients received 3.6 mg </a:t>
            </a:r>
            <a:r>
              <a:rPr lang="en-US" altLang="ja-JP" sz="1800" kern="1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pegfilgastrim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the day after </a:t>
            </a:r>
            <a:r>
              <a:rPr lang="en-US" altLang="ja-JP" sz="1800" kern="1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abazitaxel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dministration.</a:t>
            </a:r>
            <a:r>
              <a:rPr lang="ja-JP" altLang="en-US" kern="10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kern="10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TCAE 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version 4 was used for evaluation</a:t>
            </a:r>
            <a:r>
              <a:rPr lang="en-US" altLang="ja-JP" b="0" i="0" dirty="0">
                <a:effectLst/>
                <a:latin typeface="Roboto" panose="02000000000000000000" pitchFamily="2" charset="0"/>
              </a:rPr>
              <a:t>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02007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94</Words>
  <Application>Microsoft Office PowerPoint</Application>
  <PresentationFormat>ワイド画面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Roboto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永田 政義</dc:creator>
  <cp:lastModifiedBy>kamataikyoku@gmail.com</cp:lastModifiedBy>
  <cp:revision>3</cp:revision>
  <dcterms:created xsi:type="dcterms:W3CDTF">2022-09-08T11:00:26Z</dcterms:created>
  <dcterms:modified xsi:type="dcterms:W3CDTF">2022-09-18T01:12:01Z</dcterms:modified>
</cp:coreProperties>
</file>